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55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ru-RU"/>
              <a:t>Образец подзаголовк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39875-6899-42FD-AE98-6D86173C3410}" type="datetimeFigureOut">
              <a:rPr lang="ru-RU" smtClean="0"/>
              <a:t>17.12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3A6EB-4F36-4DF8-9EEE-971915094B6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2000455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39875-6899-42FD-AE98-6D86173C3410}" type="datetimeFigureOut">
              <a:rPr lang="ru-RU" smtClean="0"/>
              <a:t>17.12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3A6EB-4F36-4DF8-9EEE-971915094B6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07182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39875-6899-42FD-AE98-6D86173C3410}" type="datetimeFigureOut">
              <a:rPr lang="ru-RU" smtClean="0"/>
              <a:t>17.12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3A6EB-4F36-4DF8-9EEE-971915094B6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530040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39875-6899-42FD-AE98-6D86173C3410}" type="datetimeFigureOut">
              <a:rPr lang="ru-RU" smtClean="0"/>
              <a:t>17.12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3A6EB-4F36-4DF8-9EEE-971915094B6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77385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39875-6899-42FD-AE98-6D86173C3410}" type="datetimeFigureOut">
              <a:rPr lang="ru-RU" smtClean="0"/>
              <a:t>17.12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3A6EB-4F36-4DF8-9EEE-971915094B6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1310972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39875-6899-42FD-AE98-6D86173C3410}" type="datetimeFigureOut">
              <a:rPr lang="ru-RU" smtClean="0"/>
              <a:t>17.12.2021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3A6EB-4F36-4DF8-9EEE-971915094B6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8282171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6" name="Объект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39875-6899-42FD-AE98-6D86173C3410}" type="datetimeFigureOut">
              <a:rPr lang="ru-RU" smtClean="0"/>
              <a:t>17.12.2021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3A6EB-4F36-4DF8-9EEE-971915094B6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0319345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39875-6899-42FD-AE98-6D86173C3410}" type="datetimeFigureOut">
              <a:rPr lang="ru-RU" smtClean="0"/>
              <a:t>17.12.2021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3A6EB-4F36-4DF8-9EEE-971915094B6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7716208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39875-6899-42FD-AE98-6D86173C3410}" type="datetimeFigureOut">
              <a:rPr lang="ru-RU" smtClean="0"/>
              <a:t>17.12.2021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3A6EB-4F36-4DF8-9EEE-971915094B6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7001508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39875-6899-42FD-AE98-6D86173C3410}" type="datetimeFigureOut">
              <a:rPr lang="ru-RU" smtClean="0"/>
              <a:t>17.12.2021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3A6EB-4F36-4DF8-9EEE-971915094B6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8362527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39875-6899-42FD-AE98-6D86173C3410}" type="datetimeFigureOut">
              <a:rPr lang="ru-RU" smtClean="0"/>
              <a:t>17.12.2021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3A6EB-4F36-4DF8-9EEE-971915094B6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8576395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E39875-6899-42FD-AE98-6D86173C3410}" type="datetimeFigureOut">
              <a:rPr lang="ru-RU" smtClean="0"/>
              <a:t>17.12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43A6EB-4F36-4DF8-9EEE-971915094B6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4329437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" name="Группа 36"/>
          <p:cNvGrpSpPr/>
          <p:nvPr/>
        </p:nvGrpSpPr>
        <p:grpSpPr>
          <a:xfrm>
            <a:off x="2725039" y="1447574"/>
            <a:ext cx="7076541" cy="2423324"/>
            <a:chOff x="2725039" y="1447574"/>
            <a:chExt cx="7076541" cy="2423324"/>
          </a:xfrm>
        </p:grpSpPr>
        <p:cxnSp>
          <p:nvCxnSpPr>
            <p:cNvPr id="5" name="Прямая соединительная линия 4"/>
            <p:cNvCxnSpPr/>
            <p:nvPr/>
          </p:nvCxnSpPr>
          <p:spPr>
            <a:xfrm flipV="1">
              <a:off x="7651630" y="1623614"/>
              <a:ext cx="819510" cy="8626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TextBox 5"/>
            <p:cNvSpPr txBox="1"/>
            <p:nvPr/>
          </p:nvSpPr>
          <p:spPr>
            <a:xfrm>
              <a:off x="8471140" y="1447574"/>
              <a:ext cx="8339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Rodina</a:t>
              </a:r>
              <a:endParaRPr lang="ru-RU" dirty="0"/>
            </a:p>
          </p:txBody>
        </p:sp>
        <p:sp>
          <p:nvSpPr>
            <p:cNvPr id="7" name="Прямоугольник 6"/>
            <p:cNvSpPr/>
            <p:nvPr/>
          </p:nvSpPr>
          <p:spPr>
            <a:xfrm>
              <a:off x="8377151" y="2148780"/>
              <a:ext cx="1424429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i="1" spc="-5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Ae.speltoides </a:t>
              </a:r>
              <a:endParaRPr lang="ru-RU" dirty="0"/>
            </a:p>
          </p:txBody>
        </p:sp>
        <p:cxnSp>
          <p:nvCxnSpPr>
            <p:cNvPr id="8" name="Прямая соединительная линия 7"/>
            <p:cNvCxnSpPr/>
            <p:nvPr/>
          </p:nvCxnSpPr>
          <p:spPr>
            <a:xfrm flipV="1">
              <a:off x="7651630" y="2336958"/>
              <a:ext cx="819510" cy="8626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Молния 8"/>
            <p:cNvSpPr/>
            <p:nvPr/>
          </p:nvSpPr>
          <p:spPr>
            <a:xfrm>
              <a:off x="8603438" y="1938951"/>
              <a:ext cx="350751" cy="279532"/>
            </a:xfrm>
            <a:prstGeom prst="lightningBol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ru-RU"/>
            </a:p>
          </p:txBody>
        </p:sp>
        <p:sp>
          <p:nvSpPr>
            <p:cNvPr id="10" name="Прямоугольник 9"/>
            <p:cNvSpPr/>
            <p:nvPr/>
          </p:nvSpPr>
          <p:spPr>
            <a:xfrm>
              <a:off x="7651630" y="1849151"/>
              <a:ext cx="1065869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b="1" dirty="0"/>
                <a:t>gamma-ray</a:t>
              </a:r>
              <a:r>
                <a:rPr lang="en-US" dirty="0"/>
                <a:t> </a:t>
              </a:r>
              <a:endParaRPr lang="ru-RU" dirty="0"/>
            </a:p>
          </p:txBody>
        </p:sp>
        <p:cxnSp>
          <p:nvCxnSpPr>
            <p:cNvPr id="11" name="Прямая соединительная линия 10"/>
            <p:cNvCxnSpPr/>
            <p:nvPr/>
          </p:nvCxnSpPr>
          <p:spPr>
            <a:xfrm>
              <a:off x="7651630" y="1623614"/>
              <a:ext cx="9119" cy="72197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Прямая соединительная линия 15"/>
            <p:cNvCxnSpPr/>
            <p:nvPr/>
          </p:nvCxnSpPr>
          <p:spPr>
            <a:xfrm>
              <a:off x="7246434" y="1984599"/>
              <a:ext cx="400347" cy="3283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Box 19"/>
            <p:cNvSpPr txBox="1"/>
            <p:nvPr/>
          </p:nvSpPr>
          <p:spPr>
            <a:xfrm>
              <a:off x="6398287" y="1780998"/>
              <a:ext cx="79541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73/00i</a:t>
              </a:r>
            </a:p>
            <a:p>
              <a:r>
                <a:rPr lang="en-US" sz="1000" dirty="0"/>
                <a:t>1994 [1]</a:t>
              </a:r>
              <a:endParaRPr lang="ru-RU" sz="1000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6433223" y="2952401"/>
              <a:ext cx="186660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Novosibirskaya 29</a:t>
              </a:r>
              <a:endParaRPr lang="ru-RU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4563155" y="2321184"/>
              <a:ext cx="116410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Line 21-12</a:t>
              </a:r>
            </a:p>
            <a:p>
              <a:r>
                <a:rPr lang="en-US" sz="1000" dirty="0"/>
                <a:t>2012 [2], 2016 [3]</a:t>
              </a:r>
              <a:endParaRPr lang="ru-RU" sz="1000" dirty="0"/>
            </a:p>
          </p:txBody>
        </p:sp>
        <p:cxnSp>
          <p:nvCxnSpPr>
            <p:cNvPr id="24" name="Прямая соединительная линия 23"/>
            <p:cNvCxnSpPr/>
            <p:nvPr/>
          </p:nvCxnSpPr>
          <p:spPr>
            <a:xfrm>
              <a:off x="6032876" y="1980929"/>
              <a:ext cx="400347" cy="3283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Прямая соединительная линия 24"/>
            <p:cNvCxnSpPr/>
            <p:nvPr/>
          </p:nvCxnSpPr>
          <p:spPr>
            <a:xfrm>
              <a:off x="6047600" y="3133784"/>
              <a:ext cx="400347" cy="3283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Прямая соединительная линия 25"/>
            <p:cNvCxnSpPr/>
            <p:nvPr/>
          </p:nvCxnSpPr>
          <p:spPr>
            <a:xfrm>
              <a:off x="6038481" y="1972461"/>
              <a:ext cx="9119" cy="1161323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Прямая соединительная линия 26"/>
            <p:cNvCxnSpPr/>
            <p:nvPr/>
          </p:nvCxnSpPr>
          <p:spPr>
            <a:xfrm>
              <a:off x="5639891" y="2553122"/>
              <a:ext cx="400347" cy="3283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Прямая соединительная линия 30"/>
            <p:cNvCxnSpPr/>
            <p:nvPr/>
          </p:nvCxnSpPr>
          <p:spPr>
            <a:xfrm>
              <a:off x="4237206" y="2518112"/>
              <a:ext cx="400347" cy="3283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Прямая соединительная линия 31"/>
            <p:cNvCxnSpPr/>
            <p:nvPr/>
          </p:nvCxnSpPr>
          <p:spPr>
            <a:xfrm>
              <a:off x="4251930" y="3670967"/>
              <a:ext cx="400347" cy="3283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Прямая соединительная линия 32"/>
            <p:cNvCxnSpPr/>
            <p:nvPr/>
          </p:nvCxnSpPr>
          <p:spPr>
            <a:xfrm>
              <a:off x="4242811" y="2509644"/>
              <a:ext cx="9119" cy="1161323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Прямоугольник 33"/>
            <p:cNvSpPr/>
            <p:nvPr/>
          </p:nvSpPr>
          <p:spPr>
            <a:xfrm>
              <a:off x="4599313" y="3501566"/>
              <a:ext cx="1583190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dirty="0"/>
                <a:t>Lutescens 29-2</a:t>
              </a:r>
              <a:endParaRPr lang="ru-RU" dirty="0"/>
            </a:p>
          </p:txBody>
        </p:sp>
        <p:cxnSp>
          <p:nvCxnSpPr>
            <p:cNvPr id="35" name="Прямая соединительная линия 34"/>
            <p:cNvCxnSpPr/>
            <p:nvPr/>
          </p:nvCxnSpPr>
          <p:spPr>
            <a:xfrm>
              <a:off x="3839259" y="3083225"/>
              <a:ext cx="400347" cy="3283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Box 35"/>
            <p:cNvSpPr txBox="1"/>
            <p:nvPr/>
          </p:nvSpPr>
          <p:spPr>
            <a:xfrm>
              <a:off x="2725039" y="2798513"/>
              <a:ext cx="1120820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Line Velut</a:t>
              </a:r>
            </a:p>
            <a:p>
              <a:r>
                <a:rPr lang="en-US" sz="1000" dirty="0"/>
                <a:t>2013 [4]</a:t>
              </a:r>
              <a:endParaRPr lang="ru-RU" sz="1000" dirty="0"/>
            </a:p>
          </p:txBody>
        </p:sp>
      </p:grpSp>
      <p:sp>
        <p:nvSpPr>
          <p:cNvPr id="38" name="Прямоугольник 37"/>
          <p:cNvSpPr/>
          <p:nvPr/>
        </p:nvSpPr>
        <p:spPr>
          <a:xfrm>
            <a:off x="208578" y="4823822"/>
            <a:ext cx="11505901" cy="166199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S1. The origin of the ‘Velut’ line with a delayed heading time.</a:t>
            </a:r>
            <a:endParaRPr lang="ru-RU" dirty="0"/>
          </a:p>
          <a:p>
            <a:r>
              <a:rPr lang="en-US" dirty="0"/>
              <a:t>[1] — Lapochkina et al., 1994.</a:t>
            </a:r>
            <a:endParaRPr lang="ru-RU" dirty="0"/>
          </a:p>
          <a:p>
            <a:r>
              <a:rPr lang="en-US" dirty="0"/>
              <a:t>[2] — Adonina et al., 2012.</a:t>
            </a:r>
            <a:endParaRPr lang="ru-RU" dirty="0"/>
          </a:p>
          <a:p>
            <a:r>
              <a:rPr lang="en-US" dirty="0"/>
              <a:t>[3] — Petrash et al., 2016.</a:t>
            </a:r>
            <a:endParaRPr lang="ru-RU" dirty="0"/>
          </a:p>
          <a:p>
            <a:r>
              <a:rPr lang="en-US" dirty="0"/>
              <a:t>[4] — Salina et al., 2013.</a:t>
            </a:r>
            <a:endParaRPr lang="ru-RU" dirty="0"/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365436698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89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Тема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Salina</dc:creator>
  <cp:lastModifiedBy>MDPI-51</cp:lastModifiedBy>
  <cp:revision>9</cp:revision>
  <dcterms:created xsi:type="dcterms:W3CDTF">2021-10-29T04:04:18Z</dcterms:created>
  <dcterms:modified xsi:type="dcterms:W3CDTF">2021-12-17T13:49:22Z</dcterms:modified>
</cp:coreProperties>
</file>